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26" y="9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4454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752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077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3699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9614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1711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0237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786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0169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8606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4573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72E28-9B4E-4E95-9B12-8805F119A098}" type="datetimeFigureOut">
              <a:rPr lang="ko-KR" altLang="en-US" smtClean="0"/>
              <a:t>2023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2E502-AFBA-4D69-A6E7-DF2588ABF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8069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Treatment planning images obtained from a 66-year-old man with </a:t>
            </a:r>
            <a:r>
              <a:rPr lang="en-US" altLang="ko-KR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giosarcoma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 metastases; 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xial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, (B) sagittal, and (C) frontal 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view. 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Isodose 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e 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emonstrating 20 </a:t>
            </a:r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 in a single fraction delivered to the planning target volume 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is shown in 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yellow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2245360" y="883920"/>
            <a:ext cx="7701280" cy="5974080"/>
            <a:chOff x="2245360" y="787400"/>
            <a:chExt cx="7701280" cy="5974080"/>
          </a:xfrm>
        </p:grpSpPr>
        <p:grpSp>
          <p:nvGrpSpPr>
            <p:cNvPr id="5" name="그룹 4"/>
            <p:cNvGrpSpPr/>
            <p:nvPr/>
          </p:nvGrpSpPr>
          <p:grpSpPr>
            <a:xfrm>
              <a:off x="2245360" y="787400"/>
              <a:ext cx="7701280" cy="5974080"/>
              <a:chOff x="2250440" y="817880"/>
              <a:chExt cx="7701280" cy="5974080"/>
            </a:xfrm>
          </p:grpSpPr>
          <p:pic>
            <p:nvPicPr>
              <p:cNvPr id="2" name="그림 1">
                <a:extLst>
                  <a:ext uri="{FF2B5EF4-FFF2-40B4-BE49-F238E27FC236}">
                    <a16:creationId xmlns:a16="http://schemas.microsoft.com/office/drawing/2014/main" id="{34A6B4CF-59FE-4F07-ADE8-243651CDA6C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85" r="3061"/>
              <a:stretch/>
            </p:blipFill>
            <p:spPr>
              <a:xfrm>
                <a:off x="2250440" y="817880"/>
                <a:ext cx="7701280" cy="5974080"/>
              </a:xfrm>
              <a:prstGeom prst="rect">
                <a:avLst/>
              </a:prstGeom>
            </p:spPr>
          </p:pic>
          <p:sp>
            <p:nvSpPr>
              <p:cNvPr id="4" name="직사각형 3"/>
              <p:cNvSpPr/>
              <p:nvPr/>
            </p:nvSpPr>
            <p:spPr>
              <a:xfrm>
                <a:off x="2250440" y="5699760"/>
                <a:ext cx="1203960" cy="10414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6558280" y="1315720"/>
              <a:ext cx="3465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solidFill>
                    <a:schemeClr val="bg1"/>
                  </a:solidFill>
                </a:rPr>
                <a:t>A</a:t>
              </a:r>
              <a:endParaRPr lang="ko-KR" alt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449320" y="3911600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solidFill>
                    <a:schemeClr val="bg1"/>
                  </a:solidFill>
                </a:rPr>
                <a:t>B</a:t>
              </a:r>
              <a:endParaRPr lang="ko-KR" alt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558280" y="3911600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solidFill>
                    <a:schemeClr val="bg1"/>
                  </a:solidFill>
                </a:rPr>
                <a:t>C</a:t>
              </a:r>
              <a:endParaRPr lang="ko-KR" altLang="en-US" b="1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07074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9</TotalTime>
  <Words>56</Words>
  <Application>Microsoft Office PowerPoint</Application>
  <PresentationFormat>와이드스크린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ji</dc:creator>
  <cp:lastModifiedBy>Eunji</cp:lastModifiedBy>
  <cp:revision>30</cp:revision>
  <dcterms:created xsi:type="dcterms:W3CDTF">2023-02-11T06:21:23Z</dcterms:created>
  <dcterms:modified xsi:type="dcterms:W3CDTF">2023-08-18T07:03:06Z</dcterms:modified>
</cp:coreProperties>
</file>